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3.jpeg" ContentType="image/jpeg"/>
  <Override PartName="/ppt/media/image2.png" ContentType="image/png"/>
  <Override PartName="/ppt/media/image4.png" ContentType="image/png"/>
  <Override PartName="/ppt/media/image5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AA7F4E-75A6-49A1-A7B6-DD33D2A9570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A1CC13-BA0A-459B-A2F9-3EFD45E9AF0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BEE6A3-A159-4E5A-8265-F1226B068A8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C47E4A-0951-45C9-9346-9B62119F896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10A452-D13E-4726-ABDF-42C5F56B90A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D993C0-C86E-4D42-A43E-CD744E76E69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514642-3A12-40A0-9AD7-79511C8584E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7CB23E-79A1-4450-8F25-C3D764A891D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35E89C-3F50-4828-A40E-C168FCB9F8D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82E0BA-B9D2-4A05-88A7-BC22230E886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F5B2D7-5710-48D5-B7CD-3C3A05D9ED1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1A091B-1717-489E-B523-6CB745F9C29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B94E1F6-0B21-4005-B24E-E20E217280A3}" type="slidenum">
              <a:rPr b="0" lang="es-E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jpe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6 CuadroTexto"/>
          <p:cNvSpPr/>
          <p:nvPr/>
        </p:nvSpPr>
        <p:spPr>
          <a:xfrm>
            <a:off x="315360" y="1268280"/>
            <a:ext cx="293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8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" name="7 Imagen" descr="tumor weight sacrifice.tif"/>
          <p:cNvPicPr/>
          <p:nvPr/>
        </p:nvPicPr>
        <p:blipFill>
          <a:blip r:embed="rId1"/>
          <a:stretch/>
        </p:blipFill>
        <p:spPr>
          <a:xfrm>
            <a:off x="6576840" y="1173240"/>
            <a:ext cx="1451160" cy="1247760"/>
          </a:xfrm>
          <a:prstGeom prst="rect">
            <a:avLst/>
          </a:prstGeom>
          <a:ln w="0">
            <a:noFill/>
          </a:ln>
        </p:spPr>
      </p:pic>
      <p:pic>
        <p:nvPicPr>
          <p:cNvPr id="43" name="8 Imagen" descr="tumor volume sacrifice.tif"/>
          <p:cNvPicPr/>
          <p:nvPr/>
        </p:nvPicPr>
        <p:blipFill>
          <a:blip r:embed="rId2"/>
          <a:stretch/>
        </p:blipFill>
        <p:spPr>
          <a:xfrm>
            <a:off x="6572160" y="2544840"/>
            <a:ext cx="1455840" cy="1171440"/>
          </a:xfrm>
          <a:prstGeom prst="rect">
            <a:avLst/>
          </a:prstGeom>
          <a:ln w="0">
            <a:noFill/>
          </a:ln>
        </p:spPr>
      </p:pic>
      <p:sp>
        <p:nvSpPr>
          <p:cNvPr id="44" name="18 Rectángulo"/>
          <p:cNvSpPr/>
          <p:nvPr/>
        </p:nvSpPr>
        <p:spPr>
          <a:xfrm>
            <a:off x="34920" y="4076640"/>
            <a:ext cx="9001080" cy="1007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6.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NUDT16 exerts growth-inhibitory effects in vitro and in vivo in the T-ALL cell line MOLT-16.  (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) Restoration of NUDT16 protein expression upon stable transduction in MOLT-16 cells (NUDT16-OE) was associated with reduced viability in the 3-(4,5-dimethyl-2-thiazolyl)-2,5-diphenyl-2H-tetrazolium bromide (MTT) assay in comparison to empty-vector-transduced cells. Probabilities are those from permutation test. (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) Tumor volume monitoring of excised xenograft samples derived from NUDT16 MOLT-16 cells transduced with NUDT16 or the  empty-vector. Restoration of NUDT16 expression was associated with smaller tumors. (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) Weight and volume of the tumors excised at 30 days. Both measures were lower in the xenografts derived from MOLT-16 derived cells transduced with NUDT16. Probabilities are those associated with Student’s t-tests. Results are presented as the mean ± s.e.m., n=10.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5" name="21 Grupo"/>
          <p:cNvGrpSpPr/>
          <p:nvPr/>
        </p:nvGrpSpPr>
        <p:grpSpPr>
          <a:xfrm>
            <a:off x="3152880" y="1773360"/>
            <a:ext cx="3147840" cy="1800000"/>
            <a:chOff x="3152880" y="1773360"/>
            <a:chExt cx="3147840" cy="1800000"/>
          </a:xfrm>
        </p:grpSpPr>
        <p:pic>
          <p:nvPicPr>
            <p:cNvPr id="46" name="Picture 4" descr=""/>
            <p:cNvPicPr/>
            <p:nvPr/>
          </p:nvPicPr>
          <p:blipFill>
            <a:blip r:embed="rId3"/>
            <a:stretch/>
          </p:blipFill>
          <p:spPr>
            <a:xfrm>
              <a:off x="3152880" y="1931040"/>
              <a:ext cx="3147840" cy="16423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7" name="23 CuadroTexto"/>
            <p:cNvSpPr/>
            <p:nvPr/>
          </p:nvSpPr>
          <p:spPr>
            <a:xfrm>
              <a:off x="3978000" y="1773360"/>
              <a:ext cx="1497240" cy="413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s-ES" sz="1200" spc="-1" strike="noStrike">
                  <a:solidFill>
                    <a:srgbClr val="000000"/>
                  </a:solidFill>
                  <a:latin typeface="Calibri"/>
                </a:rPr>
                <a:t>MOLT-16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900" spc="-1" strike="noStrike">
                  <a:solidFill>
                    <a:srgbClr val="000000"/>
                  </a:solidFill>
                  <a:latin typeface="Calibri"/>
                </a:rPr>
                <a:t>(</a:t>
              </a:r>
              <a:r>
                <a:rPr b="0" lang="en-US" sz="900" spc="-1" strike="noStrike">
                  <a:solidFill>
                    <a:srgbClr val="000000"/>
                  </a:solidFill>
                  <a:latin typeface="Calibri"/>
                </a:rPr>
                <a:t>permutation</a:t>
              </a:r>
              <a:r>
                <a:rPr b="0" lang="es-ES" sz="900" spc="-1" strike="noStrike">
                  <a:solidFill>
                    <a:srgbClr val="000000"/>
                  </a:solidFill>
                  <a:latin typeface="Calibri"/>
                </a:rPr>
                <a:t> test p=0.0226)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" name="24 Conector recto"/>
            <p:cNvSpPr/>
            <p:nvPr/>
          </p:nvSpPr>
          <p:spPr>
            <a:xfrm>
              <a:off x="5580360" y="2449800"/>
              <a:ext cx="597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" name="25 Conector recto"/>
            <p:cNvSpPr/>
            <p:nvPr/>
          </p:nvSpPr>
          <p:spPr>
            <a:xfrm>
              <a:off x="5580360" y="3100680"/>
              <a:ext cx="597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" name="26 Conector recto"/>
            <p:cNvSpPr/>
            <p:nvPr/>
          </p:nvSpPr>
          <p:spPr>
            <a:xfrm>
              <a:off x="5640120" y="2445480"/>
              <a:ext cx="0" cy="659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" name="27 CuadroTexto"/>
            <p:cNvSpPr/>
            <p:nvPr/>
          </p:nvSpPr>
          <p:spPr>
            <a:xfrm>
              <a:off x="5583240" y="2710800"/>
              <a:ext cx="239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1000" spc="-1" strike="noStrike">
                  <a:solidFill>
                    <a:srgbClr val="000000"/>
                  </a:solidFill>
                  <a:latin typeface="Calibri"/>
                </a:rPr>
                <a:t>*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52" name="28 CuadroTexto"/>
          <p:cNvSpPr/>
          <p:nvPr/>
        </p:nvSpPr>
        <p:spPr>
          <a:xfrm>
            <a:off x="3042720" y="1341360"/>
            <a:ext cx="302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29 CuadroTexto"/>
          <p:cNvSpPr/>
          <p:nvPr/>
        </p:nvSpPr>
        <p:spPr>
          <a:xfrm>
            <a:off x="6164640" y="981000"/>
            <a:ext cx="276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800" spc="-1" strike="noStrike">
                <a:solidFill>
                  <a:srgbClr val="000000"/>
                </a:solidFill>
                <a:latin typeface="Calibri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54" name="20 Grupo"/>
          <p:cNvGrpSpPr/>
          <p:nvPr/>
        </p:nvGrpSpPr>
        <p:grpSpPr>
          <a:xfrm>
            <a:off x="395280" y="1628640"/>
            <a:ext cx="2592360" cy="1811520"/>
            <a:chOff x="395280" y="1628640"/>
            <a:chExt cx="2592360" cy="1811520"/>
          </a:xfrm>
        </p:grpSpPr>
        <p:pic>
          <p:nvPicPr>
            <p:cNvPr id="55" name="Picture 2" descr=""/>
            <p:cNvPicPr/>
            <p:nvPr/>
          </p:nvPicPr>
          <p:blipFill>
            <a:blip r:embed="rId4"/>
            <a:stretch/>
          </p:blipFill>
          <p:spPr>
            <a:xfrm>
              <a:off x="395280" y="1628640"/>
              <a:ext cx="2592360" cy="1811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6" name="Picture 4" descr=""/>
            <p:cNvPicPr/>
            <p:nvPr/>
          </p:nvPicPr>
          <p:blipFill>
            <a:blip r:embed="rId5"/>
            <a:stretch/>
          </p:blipFill>
          <p:spPr>
            <a:xfrm>
              <a:off x="755280" y="2018520"/>
              <a:ext cx="704520" cy="761760"/>
            </a:xfrm>
            <a:prstGeom prst="rect">
              <a:avLst/>
            </a:prstGeom>
            <a:ln w="0">
              <a:noFill/>
            </a:ln>
          </p:spPr>
        </p:pic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7-02-06T09:54:22Z</dcterms:created>
  <dc:creator>mesteller</dc:creator>
  <dc:description/>
  <dc:language>en-US</dc:language>
  <cp:lastModifiedBy>vidya.p</cp:lastModifiedBy>
  <dcterms:modified xsi:type="dcterms:W3CDTF">2017-04-10T10:34:17Z</dcterms:modified>
  <cp:revision>13</cp:revision>
  <dc:subject/>
  <dc:title>Diapositiva 1</dc:title>
</cp:coreProperties>
</file>